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F620C-9AD4-4822-ABFD-E9308659748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3A17B-F9EF-4F03-845A-2A877DCD50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643F1-484A-4A2B-98C8-B9488D34E7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4F1A4E-C54A-433B-B85A-1C968FC6F3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D1DE4-E05C-48F8-8508-DA9A954B40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2E491-BA11-49B3-8EC3-1283FEEAF0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B0292-23D6-405D-8680-6FD1260524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4ECD9-133D-4EAE-95CB-CBE786AF47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7EC73-5406-41A9-9A14-406F4CB838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B6036-610A-41D7-BF44-F4A4D890EB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6870A6-AEDB-484C-8980-83F733FE78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2A552-1C76-494D-BAF2-E493E76212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E6813B-C88D-41F6-8207-95F4688AAC38}" type="slidenum">
              <a:rPr b="0" lang="nb-NO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DBS_1.png"/>
          <p:cNvPicPr/>
          <p:nvPr/>
        </p:nvPicPr>
        <p:blipFill>
          <a:blip r:embed="rId1"/>
          <a:srcRect l="0" t="6164" r="0" b="0"/>
          <a:stretch/>
        </p:blipFill>
        <p:spPr>
          <a:xfrm>
            <a:off x="0" y="115920"/>
            <a:ext cx="9144000" cy="585792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3"/>
          <p:cNvSpPr/>
          <p:nvPr/>
        </p:nvSpPr>
        <p:spPr>
          <a:xfrm>
            <a:off x="144360" y="6090840"/>
            <a:ext cx="86756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KU70: Lupus Ku autoantigen protein p70 alias for XRCC6: X-ray repair complementing defective repair in Chinese hamster cells 6, MRE11: meiotic recombination 11 homolog A, RAD50: RAD50 homolog/DNA repair protein RAD50,  FEN1: flap structure-specific endonuclease 1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5T11:15:51Z</dcterms:created>
  <dc:creator>Siv Kjølsrud Bøhn</dc:creator>
  <dc:description/>
  <dc:language>en-US</dc:language>
  <cp:lastModifiedBy>Siv Kjølsrud Bøhn</cp:lastModifiedBy>
  <dcterms:modified xsi:type="dcterms:W3CDTF">2010-07-16T10:29:17Z</dcterms:modified>
  <cp:revision>2</cp:revision>
  <dc:subject/>
  <dc:title>Slide 1</dc:title>
</cp:coreProperties>
</file>